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264275" cy="8423275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53" userDrawn="1">
          <p15:clr>
            <a:srgbClr val="A4A3A4"/>
          </p15:clr>
        </p15:guide>
        <p15:guide id="2" pos="199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 showGuides="1">
      <p:cViewPr varScale="1">
        <p:scale>
          <a:sx n="72" d="100"/>
          <a:sy n="72" d="100"/>
        </p:scale>
        <p:origin x="2514" y="78"/>
      </p:cViewPr>
      <p:guideLst>
        <p:guide orient="horz" pos="2653"/>
        <p:guide pos="199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1378532"/>
            <a:ext cx="5324634" cy="2932548"/>
          </a:xfrm>
        </p:spPr>
        <p:txBody>
          <a:bodyPr anchor="b"/>
          <a:lstStyle>
            <a:lvl1pPr algn="ctr">
              <a:defRPr sz="4111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3035" y="4424170"/>
            <a:ext cx="4698206" cy="2033674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228" indent="0" algn="ctr">
              <a:buNone/>
              <a:defRPr sz="1370"/>
            </a:lvl2pPr>
            <a:lvl3pPr marL="626455" indent="0" algn="ctr">
              <a:buNone/>
              <a:defRPr sz="1233"/>
            </a:lvl3pPr>
            <a:lvl4pPr marL="939683" indent="0" algn="ctr">
              <a:buNone/>
              <a:defRPr sz="1096"/>
            </a:lvl4pPr>
            <a:lvl5pPr marL="1252911" indent="0" algn="ctr">
              <a:buNone/>
              <a:defRPr sz="1096"/>
            </a:lvl5pPr>
            <a:lvl6pPr marL="1566139" indent="0" algn="ctr">
              <a:buNone/>
              <a:defRPr sz="1096"/>
            </a:lvl6pPr>
            <a:lvl7pPr marL="1879366" indent="0" algn="ctr">
              <a:buNone/>
              <a:defRPr sz="1096"/>
            </a:lvl7pPr>
            <a:lvl8pPr marL="2192594" indent="0" algn="ctr">
              <a:buNone/>
              <a:defRPr sz="1096"/>
            </a:lvl8pPr>
            <a:lvl9pPr marL="2505822" indent="0" algn="ctr">
              <a:buNone/>
              <a:defRPr sz="1096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6003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80754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2872" y="448462"/>
            <a:ext cx="1350734" cy="7138336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669" y="448462"/>
            <a:ext cx="3973899" cy="7138336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1157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8631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7407" y="2099972"/>
            <a:ext cx="5402937" cy="3503848"/>
          </a:xfrm>
        </p:spPr>
        <p:txBody>
          <a:bodyPr anchor="b"/>
          <a:lstStyle>
            <a:lvl1pPr>
              <a:defRPr sz="4111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407" y="5636967"/>
            <a:ext cx="5402937" cy="1842591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/>
                </a:solidFill>
              </a:defRPr>
            </a:lvl1pPr>
            <a:lvl2pPr marL="313228" indent="0">
              <a:buNone/>
              <a:defRPr sz="1370">
                <a:solidFill>
                  <a:schemeClr val="tx1">
                    <a:tint val="75000"/>
                  </a:schemeClr>
                </a:solidFill>
              </a:defRPr>
            </a:lvl2pPr>
            <a:lvl3pPr marL="626455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3pPr>
            <a:lvl4pPr marL="93968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911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6139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936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259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82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36697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669" y="2242307"/>
            <a:ext cx="2662317" cy="534449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1289" y="2242307"/>
            <a:ext cx="2662317" cy="534449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2745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448463"/>
            <a:ext cx="5402937" cy="1628110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1485" y="2064873"/>
            <a:ext cx="2650082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1485" y="3076835"/>
            <a:ext cx="2650082" cy="452556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1289" y="2064873"/>
            <a:ext cx="2663133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1289" y="3076835"/>
            <a:ext cx="2663133" cy="452556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63448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23683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6126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3133" y="1212797"/>
            <a:ext cx="3171289" cy="5985985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18090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63133" y="1212797"/>
            <a:ext cx="3171289" cy="5985985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832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669" y="448463"/>
            <a:ext cx="5402937" cy="16281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669" y="2242307"/>
            <a:ext cx="5402937" cy="53444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A8188B-89DE-4669-91B1-F88FE6179B89}" type="datetimeFigureOut">
              <a:rPr kumimoji="1" lang="ja-JP" altLang="en-US" smtClean="0"/>
              <a:t>2020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D7434E-6EC3-4165-9315-CDE3A17932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4643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26455" rtl="0" eaLnBrk="1" latinLnBrk="0" hangingPunct="1">
        <a:lnSpc>
          <a:spcPct val="90000"/>
        </a:lnSpc>
        <a:spcBef>
          <a:spcPct val="0"/>
        </a:spcBef>
        <a:buNone/>
        <a:defRPr kumimoji="1" sz="30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4" indent="-156614" algn="l" defTabSz="626455" rtl="0" eaLnBrk="1" latinLnBrk="0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kumimoji="1" sz="1918" kern="1200">
          <a:solidFill>
            <a:schemeClr val="tx1"/>
          </a:solidFill>
          <a:latin typeface="+mn-lt"/>
          <a:ea typeface="+mn-ea"/>
          <a:cs typeface="+mn-cs"/>
        </a:defRPr>
      </a:lvl1pPr>
      <a:lvl2pPr marL="46984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3069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370" kern="1200">
          <a:solidFill>
            <a:schemeClr val="tx1"/>
          </a:solidFill>
          <a:latin typeface="+mn-lt"/>
          <a:ea typeface="+mn-ea"/>
          <a:cs typeface="+mn-cs"/>
        </a:defRPr>
      </a:lvl3pPr>
      <a:lvl4pPr marL="1096297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409525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72275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2035980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349208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662436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0" hangingPunct="1">
        <a:defRPr kumimoji="1"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235974" y="140110"/>
            <a:ext cx="2228495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upplementary Figure </a:t>
            </a:r>
            <a:r>
              <a:rPr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1</a:t>
            </a:r>
          </a:p>
          <a:p>
            <a:pPr>
              <a:lnSpc>
                <a:spcPct val="150000"/>
              </a:lnSpc>
            </a:pPr>
            <a:r>
              <a:rPr lang="en-US" altLang="ja-JP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Histograms of depressive scores</a:t>
            </a:r>
            <a:endParaRPr kumimoji="1"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35974" y="882817"/>
            <a:ext cx="1196161" cy="3170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raining</a:t>
            </a:r>
            <a:r>
              <a:rPr kumimoji="1" lang="ja-JP" altLang="en-US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kumimoji="1" lang="en-US" altLang="ja-JP" sz="11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dataset</a:t>
            </a:r>
            <a:endParaRPr kumimoji="1"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49226" y="4637243"/>
            <a:ext cx="1306768" cy="3170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1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Validation dataset</a:t>
            </a:r>
            <a:endParaRPr kumimoji="1" lang="ja-JP" altLang="en-US" sz="11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386" y="1360029"/>
            <a:ext cx="5917501" cy="23175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 rotWithShape="1">
          <a:blip r:embed="rId3"/>
          <a:srcRect r="54939"/>
          <a:stretch/>
        </p:blipFill>
        <p:spPr>
          <a:xfrm>
            <a:off x="173386" y="5171233"/>
            <a:ext cx="2701954" cy="2295000"/>
          </a:xfrm>
          <a:prstGeom prst="rect">
            <a:avLst/>
          </a:prstGeom>
        </p:spPr>
      </p:pic>
      <p:pic>
        <p:nvPicPr>
          <p:cNvPr id="2" name="図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80887" y="5171233"/>
            <a:ext cx="2610000" cy="229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35910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0</TotalTime>
  <Words>11</Words>
  <Application>Microsoft Office PowerPoint</Application>
  <PresentationFormat>ユーザー設定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 Unicode MS</vt:lpstr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hashi yuta</dc:creator>
  <cp:lastModifiedBy>takahashi yuta</cp:lastModifiedBy>
  <cp:revision>9</cp:revision>
  <dcterms:created xsi:type="dcterms:W3CDTF">2019-06-03T06:47:50Z</dcterms:created>
  <dcterms:modified xsi:type="dcterms:W3CDTF">2020-08-06T03:54:23Z</dcterms:modified>
</cp:coreProperties>
</file>